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54" autoAdjust="0"/>
    <p:restoredTop sz="94660"/>
  </p:normalViewPr>
  <p:slideViewPr>
    <p:cSldViewPr snapToGrid="0">
      <p:cViewPr varScale="1">
        <p:scale>
          <a:sx n="72" d="100"/>
          <a:sy n="72" d="100"/>
        </p:scale>
        <p:origin x="8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80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433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664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912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820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88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993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698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21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559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759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19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19380" y="185569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 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063" y="702235"/>
            <a:ext cx="6083875" cy="8301604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369000" y="9028778"/>
            <a:ext cx="61200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1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 1. </a:t>
            </a:r>
            <a:r>
              <a: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termination of TG molecular species in canola oil. Q1- (A) and product ion- (B) mass chromatograms of canola oil TG. Ions detected in Q1 mass analysis were selected as precursor ions. Mass spectra (C–J) demonstrating product ions generated from precursor ions.</a:t>
            </a:r>
            <a:endParaRPr lang="ja-JP" alt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4611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2</TotalTime>
  <Words>56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俊治</dc:creator>
  <cp:lastModifiedBy>加藤俊治</cp:lastModifiedBy>
  <cp:revision>33</cp:revision>
  <cp:lastPrinted>2017-07-23T10:57:15Z</cp:lastPrinted>
  <dcterms:created xsi:type="dcterms:W3CDTF">2017-04-21T10:59:42Z</dcterms:created>
  <dcterms:modified xsi:type="dcterms:W3CDTF">2017-08-01T06:48:28Z</dcterms:modified>
</cp:coreProperties>
</file>